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4"/>
  </p:sldMasterIdLst>
  <p:notesMasterIdLst>
    <p:notesMasterId r:id="rId6"/>
  </p:notesMasterIdLst>
  <p:sldIdLst>
    <p:sldId id="273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FD5AD25-4E17-2FA4-D475-A9C21A4D8F91}" name="Pieter-Jan De Kam" initials="PK" userId="S::atukprdm@allergytherapeutics.com::54b45d46-5a3c-43b7-a071-0778939a0d8f" providerId="AD"/>
  <p188:author id="{0845EB6C-CEE9-FFE5-0BEC-4CB4D4D72845}" name="Layhadi, Janice A" initials="" userId="S::jal107@ic.ac.uk::0a2e9531-7ec3-43d3-86a3-b0f00bbdd07c" providerId="AD"/>
  <p188:author id="{381C9578-ED66-BE76-5069-BBBE0DD1144D}" name="Sviatlana Starchenka" initials="SS" userId="S::atuksasa@allergytherapeutics.com::27ff1a91-9e63-42ec-9226-e067daa9dc2f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9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08"/>
    <p:restoredTop sz="94694"/>
  </p:normalViewPr>
  <p:slideViewPr>
    <p:cSldViewPr snapToGrid="0">
      <p:cViewPr varScale="1">
        <p:scale>
          <a:sx n="84" d="100"/>
          <a:sy n="84" d="100"/>
        </p:scale>
        <p:origin x="35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8/10/relationships/authors" Target="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hadi, Janice A" userId="0a2e9531-7ec3-43d3-86a3-b0f00bbdd07c" providerId="ADAL" clId="{EC5387F1-9F79-6F42-B0FA-09E4A11A82EE}"/>
    <pc:docChg chg="modSld">
      <pc:chgData name="Layhadi, Janice A" userId="0a2e9531-7ec3-43d3-86a3-b0f00bbdd07c" providerId="ADAL" clId="{EC5387F1-9F79-6F42-B0FA-09E4A11A82EE}" dt="2024-12-24T18:40:29.528" v="1" actId="20577"/>
      <pc:docMkLst>
        <pc:docMk/>
      </pc:docMkLst>
      <pc:sldChg chg="modSp mod">
        <pc:chgData name="Layhadi, Janice A" userId="0a2e9531-7ec3-43d3-86a3-b0f00bbdd07c" providerId="ADAL" clId="{EC5387F1-9F79-6F42-B0FA-09E4A11A82EE}" dt="2024-12-24T18:40:29.528" v="1" actId="20577"/>
        <pc:sldMkLst>
          <pc:docMk/>
          <pc:sldMk cId="3602304509" sldId="273"/>
        </pc:sldMkLst>
        <pc:spChg chg="mod">
          <ac:chgData name="Layhadi, Janice A" userId="0a2e9531-7ec3-43d3-86a3-b0f00bbdd07c" providerId="ADAL" clId="{EC5387F1-9F79-6F42-B0FA-09E4A11A82EE}" dt="2024-12-24T18:40:29.528" v="1" actId="20577"/>
          <ac:spMkLst>
            <pc:docMk/>
            <pc:sldMk cId="3602304509" sldId="273"/>
            <ac:spMk id="2" creationId="{A15A4EB9-4CF5-EEF9-87CB-AB52823798B9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5333B4-0E67-B747-8AEA-CE4C35533D2C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309145-E194-794F-A12D-6BCF59CB2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316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582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411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211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971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31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043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899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024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597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483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796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8FB87-21F3-594F-832C-EDD7C1525715}" type="datetimeFigureOut">
              <a:rPr lang="en-US" smtClean="0"/>
              <a:t>12/2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C3E31A-A9C0-5547-BC7D-95F50622A4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62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1CCB0EE-E50B-B939-91CF-9013DF1BAE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61">
            <a:extLst>
              <a:ext uri="{FF2B5EF4-FFF2-40B4-BE49-F238E27FC236}">
                <a16:creationId xmlns:a16="http://schemas.microsoft.com/office/drawing/2014/main" id="{365BDF14-373D-2988-F4A1-27A9041D75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4166" y="6134876"/>
            <a:ext cx="2263317" cy="31120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15A4EB9-4CF5-EEF9-87CB-AB52823798B9}"/>
              </a:ext>
            </a:extLst>
          </p:cNvPr>
          <p:cNvSpPr txBox="1"/>
          <p:nvPr/>
        </p:nvSpPr>
        <p:spPr>
          <a:xfrm>
            <a:off x="6126" y="953666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Figure E3</a:t>
            </a:r>
            <a:endParaRPr lang="en-US" strike="sngStrik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C229624-0B4E-12A5-F49B-2806A28D6A3B}"/>
              </a:ext>
            </a:extLst>
          </p:cNvPr>
          <p:cNvSpPr txBox="1"/>
          <p:nvPr/>
        </p:nvSpPr>
        <p:spPr>
          <a:xfrm>
            <a:off x="430945" y="217889"/>
            <a:ext cx="635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pic>
        <p:nvPicPr>
          <p:cNvPr id="6" name="Picture 5" descr="A diagram of a network&#10;&#10;Description automatically generated with medium confidence">
            <a:extLst>
              <a:ext uri="{FF2B5EF4-FFF2-40B4-BE49-F238E27FC236}">
                <a16:creationId xmlns:a16="http://schemas.microsoft.com/office/drawing/2014/main" id="{667AAC5F-5BB8-610B-14E3-D20C57F2DFC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b="16"/>
          <a:stretch/>
        </p:blipFill>
        <p:spPr>
          <a:xfrm>
            <a:off x="934270" y="761121"/>
            <a:ext cx="1676462" cy="1401189"/>
          </a:xfrm>
          <a:prstGeom prst="rect">
            <a:avLst/>
          </a:prstGeom>
        </p:spPr>
      </p:pic>
      <p:pic>
        <p:nvPicPr>
          <p:cNvPr id="8" name="Picture 7" descr="A diagram of a molecule&#10;&#10;Description automatically generated">
            <a:extLst>
              <a:ext uri="{FF2B5EF4-FFF2-40B4-BE49-F238E27FC236}">
                <a16:creationId xmlns:a16="http://schemas.microsoft.com/office/drawing/2014/main" id="{F7C4CED4-5201-5853-1DDD-9FAEB24B607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955" b="-5285"/>
          <a:stretch/>
        </p:blipFill>
        <p:spPr>
          <a:xfrm>
            <a:off x="2412442" y="763213"/>
            <a:ext cx="1332586" cy="1465200"/>
          </a:xfrm>
          <a:prstGeom prst="rect">
            <a:avLst/>
          </a:prstGeom>
        </p:spPr>
      </p:pic>
      <p:pic>
        <p:nvPicPr>
          <p:cNvPr id="15" name="Picture 14" descr="A black background with red and blue lines and dots&#10;&#10;Description automatically generated">
            <a:extLst>
              <a:ext uri="{FF2B5EF4-FFF2-40B4-BE49-F238E27FC236}">
                <a16:creationId xmlns:a16="http://schemas.microsoft.com/office/drawing/2014/main" id="{54794DBA-D2EE-9D6C-A8F4-E5819371057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942"/>
          <a:stretch/>
        </p:blipFill>
        <p:spPr>
          <a:xfrm>
            <a:off x="3542865" y="764330"/>
            <a:ext cx="1335600" cy="1394595"/>
          </a:xfrm>
          <a:prstGeom prst="rect">
            <a:avLst/>
          </a:prstGeom>
        </p:spPr>
      </p:pic>
      <p:pic>
        <p:nvPicPr>
          <p:cNvPr id="19" name="Picture 18" descr="A red and blue lines on a black background&#10;&#10;Description automatically generated">
            <a:extLst>
              <a:ext uri="{FF2B5EF4-FFF2-40B4-BE49-F238E27FC236}">
                <a16:creationId xmlns:a16="http://schemas.microsoft.com/office/drawing/2014/main" id="{EEAB370A-52F8-B78C-4B32-A979A813B09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9942"/>
          <a:stretch/>
        </p:blipFill>
        <p:spPr>
          <a:xfrm>
            <a:off x="4709063" y="761121"/>
            <a:ext cx="1324700" cy="1397804"/>
          </a:xfrm>
          <a:prstGeom prst="rect">
            <a:avLst/>
          </a:prstGeom>
        </p:spPr>
      </p:pic>
      <p:sp>
        <p:nvSpPr>
          <p:cNvPr id="51" name="Rectangle 50">
            <a:extLst>
              <a:ext uri="{FF2B5EF4-FFF2-40B4-BE49-F238E27FC236}">
                <a16:creationId xmlns:a16="http://schemas.microsoft.com/office/drawing/2014/main" id="{69A7E5B4-C5EA-6AD3-41A0-05E393828A2F}"/>
              </a:ext>
            </a:extLst>
          </p:cNvPr>
          <p:cNvSpPr/>
          <p:nvPr/>
        </p:nvSpPr>
        <p:spPr>
          <a:xfrm>
            <a:off x="781162" y="276168"/>
            <a:ext cx="5436746" cy="189893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4F1F25CC-BF52-1327-CDAE-14CEEF1AC771}"/>
              </a:ext>
            </a:extLst>
          </p:cNvPr>
          <p:cNvSpPr/>
          <p:nvPr/>
        </p:nvSpPr>
        <p:spPr>
          <a:xfrm>
            <a:off x="781161" y="282251"/>
            <a:ext cx="5436746" cy="256412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LIFERATED TH2 CELLS</a:t>
            </a:r>
          </a:p>
        </p:txBody>
      </p:sp>
      <p:pic>
        <p:nvPicPr>
          <p:cNvPr id="63" name="Picture 62" descr="A diagram of a constellation&#10;&#10;Description automatically generated">
            <a:extLst>
              <a:ext uri="{FF2B5EF4-FFF2-40B4-BE49-F238E27FC236}">
                <a16:creationId xmlns:a16="http://schemas.microsoft.com/office/drawing/2014/main" id="{54027A83-082D-BDF6-EB5D-D2BBDE0DFDE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35501" y="2731611"/>
            <a:ext cx="1674000" cy="1399359"/>
          </a:xfrm>
          <a:prstGeom prst="rect">
            <a:avLst/>
          </a:prstGeom>
        </p:spPr>
      </p:pic>
      <p:pic>
        <p:nvPicPr>
          <p:cNvPr id="65" name="Picture 64" descr="A black background with red and blue lines&#10;&#10;Description automatically generated">
            <a:extLst>
              <a:ext uri="{FF2B5EF4-FFF2-40B4-BE49-F238E27FC236}">
                <a16:creationId xmlns:a16="http://schemas.microsoft.com/office/drawing/2014/main" id="{5139D386-6CA9-23C5-9ACD-EC02C062C059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9942"/>
          <a:stretch/>
        </p:blipFill>
        <p:spPr>
          <a:xfrm>
            <a:off x="3546465" y="2729819"/>
            <a:ext cx="1332000" cy="1390835"/>
          </a:xfrm>
          <a:prstGeom prst="rect">
            <a:avLst/>
          </a:prstGeom>
        </p:spPr>
      </p:pic>
      <p:pic>
        <p:nvPicPr>
          <p:cNvPr id="67" name="Picture 66" descr="A diagram of a constellation&#10;&#10;Description automatically generated with medium confidence">
            <a:extLst>
              <a:ext uri="{FF2B5EF4-FFF2-40B4-BE49-F238E27FC236}">
                <a16:creationId xmlns:a16="http://schemas.microsoft.com/office/drawing/2014/main" id="{10661EF3-6518-2CA3-5182-7071197747C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9942"/>
          <a:stretch/>
        </p:blipFill>
        <p:spPr>
          <a:xfrm>
            <a:off x="4709063" y="2730915"/>
            <a:ext cx="1332000" cy="1390836"/>
          </a:xfrm>
          <a:prstGeom prst="rect">
            <a:avLst/>
          </a:prstGeom>
        </p:spPr>
      </p:pic>
      <p:pic>
        <p:nvPicPr>
          <p:cNvPr id="69" name="Picture 68" descr="A black background with red and blue lines and dots&#10;&#10;Description automatically generated">
            <a:extLst>
              <a:ext uri="{FF2B5EF4-FFF2-40B4-BE49-F238E27FC236}">
                <a16:creationId xmlns:a16="http://schemas.microsoft.com/office/drawing/2014/main" id="{CF75B217-7C51-FF1A-A722-4053912E790F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9942"/>
          <a:stretch/>
        </p:blipFill>
        <p:spPr>
          <a:xfrm>
            <a:off x="2413028" y="2735598"/>
            <a:ext cx="1332000" cy="139083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01E43FA3-D439-C97B-D983-F26CA8F9385F}"/>
              </a:ext>
            </a:extLst>
          </p:cNvPr>
          <p:cNvSpPr txBox="1"/>
          <p:nvPr/>
        </p:nvSpPr>
        <p:spPr>
          <a:xfrm>
            <a:off x="433961" y="2194215"/>
            <a:ext cx="635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12A93490-E4A2-35BC-02D8-763B32F26A4A}"/>
              </a:ext>
            </a:extLst>
          </p:cNvPr>
          <p:cNvSpPr/>
          <p:nvPr/>
        </p:nvSpPr>
        <p:spPr>
          <a:xfrm>
            <a:off x="781161" y="2243796"/>
            <a:ext cx="5436749" cy="1898934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483D2D46-1844-BD7D-3BFA-BDC6C67C57AC}"/>
              </a:ext>
            </a:extLst>
          </p:cNvPr>
          <p:cNvSpPr/>
          <p:nvPr/>
        </p:nvSpPr>
        <p:spPr>
          <a:xfrm>
            <a:off x="781161" y="2249879"/>
            <a:ext cx="5436749" cy="256412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LIFERATED TH2A CELLS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BEFE3672-44E0-5124-0592-9A34F0A4AD55}"/>
              </a:ext>
            </a:extLst>
          </p:cNvPr>
          <p:cNvSpPr/>
          <p:nvPr/>
        </p:nvSpPr>
        <p:spPr>
          <a:xfrm>
            <a:off x="2580548" y="4537216"/>
            <a:ext cx="943200" cy="259161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Q Grass Extended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5F68F78-5D8A-4482-948E-17ECD3897CE8}"/>
              </a:ext>
            </a:extLst>
          </p:cNvPr>
          <p:cNvSpPr/>
          <p:nvPr/>
        </p:nvSpPr>
        <p:spPr>
          <a:xfrm>
            <a:off x="1346234" y="4537216"/>
            <a:ext cx="946203" cy="256411"/>
          </a:xfrm>
          <a:prstGeom prst="rect">
            <a:avLst/>
          </a:prstGeom>
          <a:solidFill>
            <a:srgbClr val="00905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Q Grass Conventional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8142E76F-00B4-7A60-89B4-111EA0521E81}"/>
              </a:ext>
            </a:extLst>
          </p:cNvPr>
          <p:cNvSpPr/>
          <p:nvPr/>
        </p:nvSpPr>
        <p:spPr>
          <a:xfrm>
            <a:off x="4994529" y="4534464"/>
            <a:ext cx="950400" cy="25916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lacebo 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13112728-FFC5-0B5A-4E74-EBC4F8AFF5C8}"/>
              </a:ext>
            </a:extLst>
          </p:cNvPr>
          <p:cNvSpPr/>
          <p:nvPr/>
        </p:nvSpPr>
        <p:spPr>
          <a:xfrm>
            <a:off x="3788201" y="4536408"/>
            <a:ext cx="950400" cy="259160"/>
          </a:xfrm>
          <a:prstGeom prst="rect">
            <a:avLst/>
          </a:prstGeom>
          <a:solidFill>
            <a:srgbClr val="0432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lacebo + MCT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7DD51CF5-27F4-15AD-07F7-B74BF1ACEE25}"/>
              </a:ext>
            </a:extLst>
          </p:cNvPr>
          <p:cNvSpPr/>
          <p:nvPr/>
        </p:nvSpPr>
        <p:spPr>
          <a:xfrm>
            <a:off x="781160" y="4216062"/>
            <a:ext cx="5436750" cy="219655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C0EEEF69-4121-854E-6EC3-6F0DBE08F5D5}"/>
              </a:ext>
            </a:extLst>
          </p:cNvPr>
          <p:cNvSpPr/>
          <p:nvPr/>
        </p:nvSpPr>
        <p:spPr>
          <a:xfrm>
            <a:off x="781159" y="4222144"/>
            <a:ext cx="5436750" cy="256412"/>
          </a:xfrm>
          <a:prstGeom prst="rect">
            <a:avLst/>
          </a:prstGeom>
          <a:solidFill>
            <a:srgbClr val="00206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b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LIFERATED TFH CELLS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0266ED16-7A1E-2CB4-20E3-81533990917E}"/>
              </a:ext>
            </a:extLst>
          </p:cNvPr>
          <p:cNvSpPr txBox="1"/>
          <p:nvPr/>
        </p:nvSpPr>
        <p:spPr>
          <a:xfrm>
            <a:off x="425927" y="4213259"/>
            <a:ext cx="635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pic>
        <p:nvPicPr>
          <p:cNvPr id="56" name="Picture 55" descr="A diagram of a constellation&#10;&#10;Description automatically generated">
            <a:extLst>
              <a:ext uri="{FF2B5EF4-FFF2-40B4-BE49-F238E27FC236}">
                <a16:creationId xmlns:a16="http://schemas.microsoft.com/office/drawing/2014/main" id="{53C8A228-2B5B-99D4-3BEE-720721C59F3D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9503"/>
          <a:stretch/>
        </p:blipFill>
        <p:spPr>
          <a:xfrm>
            <a:off x="1124136" y="4700418"/>
            <a:ext cx="1411200" cy="1394670"/>
          </a:xfrm>
          <a:prstGeom prst="rect">
            <a:avLst/>
          </a:prstGeom>
        </p:spPr>
      </p:pic>
      <p:pic>
        <p:nvPicPr>
          <p:cNvPr id="57" name="Picture 56" descr="A diagram of a graph&#10;&#10;Description automatically generated">
            <a:extLst>
              <a:ext uri="{FF2B5EF4-FFF2-40B4-BE49-F238E27FC236}">
                <a16:creationId xmlns:a16="http://schemas.microsoft.com/office/drawing/2014/main" id="{8A50D0DA-B0F9-C2DC-15C1-742104409C7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9548"/>
          <a:stretch/>
        </p:blipFill>
        <p:spPr>
          <a:xfrm>
            <a:off x="2359502" y="4710578"/>
            <a:ext cx="1411200" cy="1395446"/>
          </a:xfrm>
          <a:prstGeom prst="rect">
            <a:avLst/>
          </a:prstGeom>
        </p:spPr>
      </p:pic>
      <p:pic>
        <p:nvPicPr>
          <p:cNvPr id="59" name="Picture 58" descr="A black background with red and blue lines and dots&#10;&#10;Description automatically generated">
            <a:extLst>
              <a:ext uri="{FF2B5EF4-FFF2-40B4-BE49-F238E27FC236}">
                <a16:creationId xmlns:a16="http://schemas.microsoft.com/office/drawing/2014/main" id="{4CA85730-AC7E-3B58-5095-B83B6A4F0BE6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9548"/>
          <a:stretch/>
        </p:blipFill>
        <p:spPr>
          <a:xfrm>
            <a:off x="3574487" y="4711767"/>
            <a:ext cx="1411200" cy="1395446"/>
          </a:xfrm>
          <a:prstGeom prst="rect">
            <a:avLst/>
          </a:prstGeom>
        </p:spPr>
      </p:pic>
      <p:pic>
        <p:nvPicPr>
          <p:cNvPr id="60" name="Picture 59" descr="A red and blue lines and dots on a black background&#10;&#10;Description automatically generated">
            <a:extLst>
              <a:ext uri="{FF2B5EF4-FFF2-40B4-BE49-F238E27FC236}">
                <a16:creationId xmlns:a16="http://schemas.microsoft.com/office/drawing/2014/main" id="{87234921-14A4-4042-5C77-7C37ABEDB53A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17674"/>
          <a:stretch/>
        </p:blipFill>
        <p:spPr>
          <a:xfrm>
            <a:off x="4745940" y="4707903"/>
            <a:ext cx="1445466" cy="1396800"/>
          </a:xfrm>
          <a:prstGeom prst="rect">
            <a:avLst/>
          </a:prstGeom>
        </p:spPr>
      </p:pic>
      <p:pic>
        <p:nvPicPr>
          <p:cNvPr id="61" name="Picture 60" descr="A diagram of a constellation&#10;&#10;Description automatically generated">
            <a:extLst>
              <a:ext uri="{FF2B5EF4-FFF2-40B4-BE49-F238E27FC236}">
                <a16:creationId xmlns:a16="http://schemas.microsoft.com/office/drawing/2014/main" id="{A354F5CE-4CD9-EF76-E8AE-2F483AB654A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145" r="84181"/>
          <a:stretch/>
        </p:blipFill>
        <p:spPr>
          <a:xfrm>
            <a:off x="825624" y="4602058"/>
            <a:ext cx="311170" cy="168705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6ACF81C-3CC9-55A4-01C3-FF80EBF5E6F7}"/>
              </a:ext>
            </a:extLst>
          </p:cNvPr>
          <p:cNvSpPr/>
          <p:nvPr/>
        </p:nvSpPr>
        <p:spPr>
          <a:xfrm>
            <a:off x="2561069" y="2568943"/>
            <a:ext cx="943200" cy="259161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Q Grass Extended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F37E231-7D39-AA01-BD9F-6B2F10DD4A78}"/>
              </a:ext>
            </a:extLst>
          </p:cNvPr>
          <p:cNvSpPr/>
          <p:nvPr/>
        </p:nvSpPr>
        <p:spPr>
          <a:xfrm>
            <a:off x="1420018" y="2560877"/>
            <a:ext cx="946203" cy="256411"/>
          </a:xfrm>
          <a:prstGeom prst="rect">
            <a:avLst/>
          </a:prstGeom>
          <a:solidFill>
            <a:srgbClr val="00905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Q Grass Conventional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CFF0EF6D-0B9D-5118-C2FB-141F41D9FE4F}"/>
              </a:ext>
            </a:extLst>
          </p:cNvPr>
          <p:cNvSpPr/>
          <p:nvPr/>
        </p:nvSpPr>
        <p:spPr>
          <a:xfrm>
            <a:off x="4856806" y="2566191"/>
            <a:ext cx="950400" cy="25916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lacebo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BF84BB2-AC23-DAC0-3C94-F57DAB4D04C6}"/>
              </a:ext>
            </a:extLst>
          </p:cNvPr>
          <p:cNvSpPr/>
          <p:nvPr/>
        </p:nvSpPr>
        <p:spPr>
          <a:xfrm>
            <a:off x="3689893" y="2568135"/>
            <a:ext cx="950400" cy="259160"/>
          </a:xfrm>
          <a:prstGeom prst="rect">
            <a:avLst/>
          </a:prstGeom>
          <a:solidFill>
            <a:srgbClr val="0432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lacebo + MCT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49166F5-D8FD-750D-BB82-3A33BFC0F5B9}"/>
              </a:ext>
            </a:extLst>
          </p:cNvPr>
          <p:cNvSpPr/>
          <p:nvPr/>
        </p:nvSpPr>
        <p:spPr>
          <a:xfrm>
            <a:off x="2559021" y="590190"/>
            <a:ext cx="943200" cy="259161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Q Grass Extended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E9DC6E1-089A-C95B-EAEB-ACD564590A95}"/>
              </a:ext>
            </a:extLst>
          </p:cNvPr>
          <p:cNvSpPr/>
          <p:nvPr/>
        </p:nvSpPr>
        <p:spPr>
          <a:xfrm>
            <a:off x="1419302" y="590190"/>
            <a:ext cx="946203" cy="256411"/>
          </a:xfrm>
          <a:prstGeom prst="rect">
            <a:avLst/>
          </a:prstGeom>
          <a:solidFill>
            <a:srgbClr val="00905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Q Grass Conventional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E43AA64-5DC6-711C-641C-CBA62CBC6FEC}"/>
              </a:ext>
            </a:extLst>
          </p:cNvPr>
          <p:cNvSpPr/>
          <p:nvPr/>
        </p:nvSpPr>
        <p:spPr>
          <a:xfrm>
            <a:off x="4846874" y="587438"/>
            <a:ext cx="950400" cy="25916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lacebo 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329428A-3267-BBC7-5057-5CDE67AD14EA}"/>
              </a:ext>
            </a:extLst>
          </p:cNvPr>
          <p:cNvSpPr/>
          <p:nvPr/>
        </p:nvSpPr>
        <p:spPr>
          <a:xfrm>
            <a:off x="3687844" y="589382"/>
            <a:ext cx="950400" cy="259160"/>
          </a:xfrm>
          <a:prstGeom prst="rect">
            <a:avLst/>
          </a:prstGeom>
          <a:solidFill>
            <a:srgbClr val="0432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lacebo + MCT</a:t>
            </a:r>
          </a:p>
        </p:txBody>
      </p:sp>
    </p:spTree>
    <p:extLst>
      <p:ext uri="{BB962C8B-B14F-4D97-AF65-F5344CB8AC3E}">
        <p14:creationId xmlns:p14="http://schemas.microsoft.com/office/powerpoint/2010/main" val="3602304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AE52512272D44BB074101A15BF15E9" ma:contentTypeVersion="16" ma:contentTypeDescription="Create a new document." ma:contentTypeScope="" ma:versionID="7bc4ed5e1bf1c330d545856942c2ea87">
  <xsd:schema xmlns:xsd="http://www.w3.org/2001/XMLSchema" xmlns:xs="http://www.w3.org/2001/XMLSchema" xmlns:p="http://schemas.microsoft.com/office/2006/metadata/properties" xmlns:ns2="dddeb55e-3631-4795-802d-e3c70af94a98" xmlns:ns3="eb07c517-3670-477e-a221-b145e09753ca" targetNamespace="http://schemas.microsoft.com/office/2006/metadata/properties" ma:root="true" ma:fieldsID="e134757dc0b3567c9dfb2bd7333da9d0" ns2:_="" ns3:_="">
    <xsd:import namespace="dddeb55e-3631-4795-802d-e3c70af94a98"/>
    <xsd:import namespace="eb07c517-3670-477e-a221-b145e09753c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ReviewFlow" minOccurs="0"/>
                <xsd:element ref="ns2:ApprovalFlow" minOccurs="0"/>
                <xsd:element ref="ns2:WFInitiator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ddeb55e-3631-4795-802d-e3c70af94a9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ReviewFlow" ma:index="12" nillable="true" ma:displayName="ReviewFlow" ma:internalName="ReviewFlow">
      <xsd:simpleType>
        <xsd:restriction base="dms:Choice">
          <xsd:enumeration value="Not Started"/>
          <xsd:enumeration value="In Progress"/>
          <xsd:enumeration value="Reviewed"/>
        </xsd:restriction>
      </xsd:simpleType>
    </xsd:element>
    <xsd:element name="ApprovalFlow" ma:index="13" nillable="true" ma:displayName="ApprovalFlow" ma:internalName="ApprovalFlow">
      <xsd:simpleType>
        <xsd:restriction base="dms:Choice">
          <xsd:enumeration value="Not Started"/>
          <xsd:enumeration value="In Progress"/>
          <xsd:enumeration value="Approved"/>
        </xsd:restriction>
      </xsd:simpleType>
    </xsd:element>
    <xsd:element name="WFInitiator" ma:index="14" nillable="true" ma:displayName="WFInitiator" ma:internalName="WFInitiator">
      <xsd:simpleType>
        <xsd:restriction base="dms:Text"/>
      </xsd:simpleType>
    </xsd:element>
    <xsd:element name="lcf76f155ced4ddcb4097134ff3c332f" ma:index="18" nillable="true" ma:taxonomy="true" ma:internalName="lcf76f155ced4ddcb4097134ff3c332f" ma:taxonomyFieldName="MediaServiceImageTags" ma:displayName="Image Tags" ma:readOnly="false" ma:fieldId="{5cf76f15-5ced-4ddc-b409-7134ff3c332f}" ma:taxonomyMulti="true" ma:sspId="a306c6d1-e6a6-429d-9fde-c8374a10a63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2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3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b07c517-3670-477e-a221-b145e09753ca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9" nillable="true" ma:displayName="Taxonomy Catch All Column" ma:hidden="true" ma:list="{5f00fec2-6b66-4ca0-83db-1356f88b302c}" ma:internalName="TaxCatchAll" ma:showField="CatchAllData" ma:web="eb07c517-3670-477e-a221-b145e09753c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WFInitiator xmlns="dddeb55e-3631-4795-802d-e3c70af94a98">Sviatlana Starchenka</WFInitiator>
    <ApprovalFlow xmlns="dddeb55e-3631-4795-802d-e3c70af94a98" xsi:nil="true"/>
    <ReviewFlow xmlns="dddeb55e-3631-4795-802d-e3c70af94a98">Reviewed</ReviewFlow>
    <lcf76f155ced4ddcb4097134ff3c332f xmlns="dddeb55e-3631-4795-802d-e3c70af94a98">
      <Terms xmlns="http://schemas.microsoft.com/office/infopath/2007/PartnerControls"/>
    </lcf76f155ced4ddcb4097134ff3c332f>
    <TaxCatchAll xmlns="eb07c517-3670-477e-a221-b145e09753ca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FBE8BE0-5A87-4DB2-A200-8F8EF6BC7E5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ddeb55e-3631-4795-802d-e3c70af94a98"/>
    <ds:schemaRef ds:uri="eb07c517-3670-477e-a221-b145e09753c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EF07CE5-31E1-4928-91ED-572946AB7720}">
  <ds:schemaRefs>
    <ds:schemaRef ds:uri="http://schemas.openxmlformats.org/package/2006/metadata/core-properties"/>
    <ds:schemaRef ds:uri="http://purl.org/dc/elements/1.1/"/>
    <ds:schemaRef ds:uri="http://purl.org/dc/dcmitype/"/>
    <ds:schemaRef ds:uri="http://schemas.microsoft.com/office/2006/documentManagement/types"/>
    <ds:schemaRef ds:uri="eb07c517-3670-477e-a221-b145e09753ca"/>
    <ds:schemaRef ds:uri="http://schemas.microsoft.com/office/2006/metadata/properties"/>
    <ds:schemaRef ds:uri="dddeb55e-3631-4795-802d-e3c70af94a98"/>
    <ds:schemaRef ds:uri="http://schemas.microsoft.com/office/infopath/2007/PartnerControls"/>
    <ds:schemaRef ds:uri="http://www.w3.org/XML/1998/namespace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B6ADC2D3-660F-414D-B034-C5F16644DE2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829</TotalTime>
  <Words>47</Words>
  <Application>Microsoft Macintosh PowerPoint</Application>
  <PresentationFormat>A4 Paper (210x297 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yhadi, Janice A</dc:creator>
  <cp:lastModifiedBy>Layhadi, Janice A</cp:lastModifiedBy>
  <cp:revision>15</cp:revision>
  <dcterms:created xsi:type="dcterms:W3CDTF">2024-01-07T19:08:07Z</dcterms:created>
  <dcterms:modified xsi:type="dcterms:W3CDTF">2024-12-24T18:40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AE52512272D44BB074101A15BF15E9</vt:lpwstr>
  </property>
  <property fmtid="{D5CDD505-2E9C-101B-9397-08002B2CF9AE}" pid="3" name="MediaServiceImageTags">
    <vt:lpwstr/>
  </property>
</Properties>
</file>